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0" r:id="rId1"/>
  </p:sldMasterIdLst>
  <p:sldIdLst>
    <p:sldId id="263" r:id="rId2"/>
    <p:sldId id="270" r:id="rId3"/>
    <p:sldId id="274" r:id="rId4"/>
    <p:sldId id="275" r:id="rId5"/>
  </p:sldIdLst>
  <p:sldSz cx="9312275" cy="54181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07" userDrawn="1">
          <p15:clr>
            <a:srgbClr val="A4A3A4"/>
          </p15:clr>
        </p15:guide>
        <p15:guide id="2" pos="293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81" autoAdjust="0"/>
    <p:restoredTop sz="94660"/>
  </p:normalViewPr>
  <p:slideViewPr>
    <p:cSldViewPr snapToGrid="0" showGuides="1">
      <p:cViewPr varScale="1">
        <p:scale>
          <a:sx n="134" d="100"/>
          <a:sy n="134" d="100"/>
        </p:scale>
        <p:origin x="138" y="276"/>
      </p:cViewPr>
      <p:guideLst>
        <p:guide orient="horz" pos="1707"/>
        <p:guide pos="293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4035" y="886719"/>
            <a:ext cx="6984206" cy="1886315"/>
          </a:xfrm>
        </p:spPr>
        <p:txBody>
          <a:bodyPr anchor="b"/>
          <a:lstStyle>
            <a:lvl1pPr algn="ctr">
              <a:defRPr sz="4583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4035" y="2845777"/>
            <a:ext cx="6984206" cy="1308129"/>
          </a:xfrm>
        </p:spPr>
        <p:txBody>
          <a:bodyPr/>
          <a:lstStyle>
            <a:lvl1pPr marL="0" indent="0" algn="ctr">
              <a:buNone/>
              <a:defRPr sz="1833"/>
            </a:lvl1pPr>
            <a:lvl2pPr marL="349209" indent="0" algn="ctr">
              <a:buNone/>
              <a:defRPr sz="1528"/>
            </a:lvl2pPr>
            <a:lvl3pPr marL="698419" indent="0" algn="ctr">
              <a:buNone/>
              <a:defRPr sz="1375"/>
            </a:lvl3pPr>
            <a:lvl4pPr marL="1047628" indent="0" algn="ctr">
              <a:buNone/>
              <a:defRPr sz="1222"/>
            </a:lvl4pPr>
            <a:lvl5pPr marL="1396837" indent="0" algn="ctr">
              <a:buNone/>
              <a:defRPr sz="1222"/>
            </a:lvl5pPr>
            <a:lvl6pPr marL="1746047" indent="0" algn="ctr">
              <a:buNone/>
              <a:defRPr sz="1222"/>
            </a:lvl6pPr>
            <a:lvl7pPr marL="2095256" indent="0" algn="ctr">
              <a:buNone/>
              <a:defRPr sz="1222"/>
            </a:lvl7pPr>
            <a:lvl8pPr marL="2444466" indent="0" algn="ctr">
              <a:buNone/>
              <a:defRPr sz="1222"/>
            </a:lvl8pPr>
            <a:lvl9pPr marL="2793675" indent="0" algn="ctr">
              <a:buNone/>
              <a:defRPr sz="1222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E75A-626F-43DC-80CD-FA5F772DBA88}" type="datetimeFigureOut">
              <a:rPr lang="zh-CN" altLang="en-US" smtClean="0"/>
              <a:t>2026/1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43A25-E377-46A9-9087-D4C097D2E4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71388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E75A-626F-43DC-80CD-FA5F772DBA88}" type="datetimeFigureOut">
              <a:rPr lang="zh-CN" altLang="en-US" smtClean="0"/>
              <a:t>2026/1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43A25-E377-46A9-9087-D4C097D2E4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3374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64097" y="288465"/>
            <a:ext cx="2007959" cy="459162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40219" y="288465"/>
            <a:ext cx="5907474" cy="459162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E75A-626F-43DC-80CD-FA5F772DBA88}" type="datetimeFigureOut">
              <a:rPr lang="zh-CN" altLang="en-US" smtClean="0"/>
              <a:t>2026/1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43A25-E377-46A9-9087-D4C097D2E4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9006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E75A-626F-43DC-80CD-FA5F772DBA88}" type="datetimeFigureOut">
              <a:rPr lang="zh-CN" altLang="en-US" smtClean="0"/>
              <a:t>2026/1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43A25-E377-46A9-9087-D4C097D2E4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1164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5369" y="1350772"/>
            <a:ext cx="8031837" cy="2253795"/>
          </a:xfrm>
        </p:spPr>
        <p:txBody>
          <a:bodyPr anchor="b"/>
          <a:lstStyle>
            <a:lvl1pPr>
              <a:defRPr sz="4583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5369" y="3625889"/>
            <a:ext cx="8031837" cy="1185217"/>
          </a:xfrm>
        </p:spPr>
        <p:txBody>
          <a:bodyPr/>
          <a:lstStyle>
            <a:lvl1pPr marL="0" indent="0">
              <a:buNone/>
              <a:defRPr sz="1833">
                <a:solidFill>
                  <a:schemeClr val="tx1">
                    <a:tint val="75000"/>
                  </a:schemeClr>
                </a:solidFill>
              </a:defRPr>
            </a:lvl1pPr>
            <a:lvl2pPr marL="349209" indent="0">
              <a:buNone/>
              <a:defRPr sz="1528">
                <a:solidFill>
                  <a:schemeClr val="tx1">
                    <a:tint val="75000"/>
                  </a:schemeClr>
                </a:solidFill>
              </a:defRPr>
            </a:lvl2pPr>
            <a:lvl3pPr marL="698419" indent="0">
              <a:buNone/>
              <a:defRPr sz="1375">
                <a:solidFill>
                  <a:schemeClr val="tx1">
                    <a:tint val="75000"/>
                  </a:schemeClr>
                </a:solidFill>
              </a:defRPr>
            </a:lvl3pPr>
            <a:lvl4pPr marL="1047628" indent="0">
              <a:buNone/>
              <a:defRPr sz="1222">
                <a:solidFill>
                  <a:schemeClr val="tx1">
                    <a:tint val="75000"/>
                  </a:schemeClr>
                </a:solidFill>
              </a:defRPr>
            </a:lvl4pPr>
            <a:lvl5pPr marL="1396837" indent="0">
              <a:buNone/>
              <a:defRPr sz="1222">
                <a:solidFill>
                  <a:schemeClr val="tx1">
                    <a:tint val="75000"/>
                  </a:schemeClr>
                </a:solidFill>
              </a:defRPr>
            </a:lvl5pPr>
            <a:lvl6pPr marL="1746047" indent="0">
              <a:buNone/>
              <a:defRPr sz="1222">
                <a:solidFill>
                  <a:schemeClr val="tx1">
                    <a:tint val="75000"/>
                  </a:schemeClr>
                </a:solidFill>
              </a:defRPr>
            </a:lvl6pPr>
            <a:lvl7pPr marL="2095256" indent="0">
              <a:buNone/>
              <a:defRPr sz="1222">
                <a:solidFill>
                  <a:schemeClr val="tx1">
                    <a:tint val="75000"/>
                  </a:schemeClr>
                </a:solidFill>
              </a:defRPr>
            </a:lvl7pPr>
            <a:lvl8pPr marL="2444466" indent="0">
              <a:buNone/>
              <a:defRPr sz="1222">
                <a:solidFill>
                  <a:schemeClr val="tx1">
                    <a:tint val="75000"/>
                  </a:schemeClr>
                </a:solidFill>
              </a:defRPr>
            </a:lvl8pPr>
            <a:lvl9pPr marL="2793675" indent="0">
              <a:buNone/>
              <a:defRPr sz="12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E75A-626F-43DC-80CD-FA5F772DBA88}" type="datetimeFigureOut">
              <a:rPr lang="zh-CN" altLang="en-US" smtClean="0"/>
              <a:t>2026/1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43A25-E377-46A9-9087-D4C097D2E4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85917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40219" y="1442328"/>
            <a:ext cx="3957717" cy="343775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4339" y="1442328"/>
            <a:ext cx="3957717" cy="343775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E75A-626F-43DC-80CD-FA5F772DBA88}" type="datetimeFigureOut">
              <a:rPr lang="zh-CN" altLang="en-US" smtClean="0"/>
              <a:t>2026/1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43A25-E377-46A9-9087-D4C097D2E4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6544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432" y="288466"/>
            <a:ext cx="8031837" cy="10472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1432" y="1328197"/>
            <a:ext cx="3939528" cy="650929"/>
          </a:xfrm>
        </p:spPr>
        <p:txBody>
          <a:bodyPr anchor="b"/>
          <a:lstStyle>
            <a:lvl1pPr marL="0" indent="0">
              <a:buNone/>
              <a:defRPr sz="1833" b="1"/>
            </a:lvl1pPr>
            <a:lvl2pPr marL="349209" indent="0">
              <a:buNone/>
              <a:defRPr sz="1528" b="1"/>
            </a:lvl2pPr>
            <a:lvl3pPr marL="698419" indent="0">
              <a:buNone/>
              <a:defRPr sz="1375" b="1"/>
            </a:lvl3pPr>
            <a:lvl4pPr marL="1047628" indent="0">
              <a:buNone/>
              <a:defRPr sz="1222" b="1"/>
            </a:lvl4pPr>
            <a:lvl5pPr marL="1396837" indent="0">
              <a:buNone/>
              <a:defRPr sz="1222" b="1"/>
            </a:lvl5pPr>
            <a:lvl6pPr marL="1746047" indent="0">
              <a:buNone/>
              <a:defRPr sz="1222" b="1"/>
            </a:lvl6pPr>
            <a:lvl7pPr marL="2095256" indent="0">
              <a:buNone/>
              <a:defRPr sz="1222" b="1"/>
            </a:lvl7pPr>
            <a:lvl8pPr marL="2444466" indent="0">
              <a:buNone/>
              <a:defRPr sz="1222" b="1"/>
            </a:lvl8pPr>
            <a:lvl9pPr marL="2793675" indent="0">
              <a:buNone/>
              <a:defRPr sz="122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1432" y="1979126"/>
            <a:ext cx="3939528" cy="291099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14339" y="1328197"/>
            <a:ext cx="3958930" cy="650929"/>
          </a:xfrm>
        </p:spPr>
        <p:txBody>
          <a:bodyPr anchor="b"/>
          <a:lstStyle>
            <a:lvl1pPr marL="0" indent="0">
              <a:buNone/>
              <a:defRPr sz="1833" b="1"/>
            </a:lvl1pPr>
            <a:lvl2pPr marL="349209" indent="0">
              <a:buNone/>
              <a:defRPr sz="1528" b="1"/>
            </a:lvl2pPr>
            <a:lvl3pPr marL="698419" indent="0">
              <a:buNone/>
              <a:defRPr sz="1375" b="1"/>
            </a:lvl3pPr>
            <a:lvl4pPr marL="1047628" indent="0">
              <a:buNone/>
              <a:defRPr sz="1222" b="1"/>
            </a:lvl4pPr>
            <a:lvl5pPr marL="1396837" indent="0">
              <a:buNone/>
              <a:defRPr sz="1222" b="1"/>
            </a:lvl5pPr>
            <a:lvl6pPr marL="1746047" indent="0">
              <a:buNone/>
              <a:defRPr sz="1222" b="1"/>
            </a:lvl6pPr>
            <a:lvl7pPr marL="2095256" indent="0">
              <a:buNone/>
              <a:defRPr sz="1222" b="1"/>
            </a:lvl7pPr>
            <a:lvl8pPr marL="2444466" indent="0">
              <a:buNone/>
              <a:defRPr sz="1222" b="1"/>
            </a:lvl8pPr>
            <a:lvl9pPr marL="2793675" indent="0">
              <a:buNone/>
              <a:defRPr sz="122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14339" y="1979126"/>
            <a:ext cx="3958930" cy="291099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E75A-626F-43DC-80CD-FA5F772DBA88}" type="datetimeFigureOut">
              <a:rPr lang="zh-CN" altLang="en-US" smtClean="0"/>
              <a:t>2026/1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43A25-E377-46A9-9087-D4C097D2E4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2545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E75A-626F-43DC-80CD-FA5F772DBA88}" type="datetimeFigureOut">
              <a:rPr lang="zh-CN" altLang="en-US" smtClean="0"/>
              <a:t>2026/1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43A25-E377-46A9-9087-D4C097D2E4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2756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E75A-626F-43DC-80CD-FA5F772DBA88}" type="datetimeFigureOut">
              <a:rPr lang="zh-CN" altLang="en-US" smtClean="0"/>
              <a:t>2026/1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43A25-E377-46A9-9087-D4C097D2E4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8249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432" y="361209"/>
            <a:ext cx="3003451" cy="1264232"/>
          </a:xfrm>
        </p:spPr>
        <p:txBody>
          <a:bodyPr anchor="b"/>
          <a:lstStyle>
            <a:lvl1pPr>
              <a:defRPr sz="244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58930" y="780112"/>
            <a:ext cx="4714339" cy="3850390"/>
          </a:xfrm>
        </p:spPr>
        <p:txBody>
          <a:bodyPr/>
          <a:lstStyle>
            <a:lvl1pPr>
              <a:defRPr sz="2444"/>
            </a:lvl1pPr>
            <a:lvl2pPr>
              <a:defRPr sz="2139"/>
            </a:lvl2pPr>
            <a:lvl3pPr>
              <a:defRPr sz="1833"/>
            </a:lvl3pPr>
            <a:lvl4pPr>
              <a:defRPr sz="1528"/>
            </a:lvl4pPr>
            <a:lvl5pPr>
              <a:defRPr sz="1528"/>
            </a:lvl5pPr>
            <a:lvl6pPr>
              <a:defRPr sz="1528"/>
            </a:lvl6pPr>
            <a:lvl7pPr>
              <a:defRPr sz="1528"/>
            </a:lvl7pPr>
            <a:lvl8pPr>
              <a:defRPr sz="1528"/>
            </a:lvl8pPr>
            <a:lvl9pPr>
              <a:defRPr sz="152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1432" y="1625442"/>
            <a:ext cx="3003451" cy="3011331"/>
          </a:xfrm>
        </p:spPr>
        <p:txBody>
          <a:bodyPr/>
          <a:lstStyle>
            <a:lvl1pPr marL="0" indent="0">
              <a:buNone/>
              <a:defRPr sz="1222"/>
            </a:lvl1pPr>
            <a:lvl2pPr marL="349209" indent="0">
              <a:buNone/>
              <a:defRPr sz="1069"/>
            </a:lvl2pPr>
            <a:lvl3pPr marL="698419" indent="0">
              <a:buNone/>
              <a:defRPr sz="917"/>
            </a:lvl3pPr>
            <a:lvl4pPr marL="1047628" indent="0">
              <a:buNone/>
              <a:defRPr sz="764"/>
            </a:lvl4pPr>
            <a:lvl5pPr marL="1396837" indent="0">
              <a:buNone/>
              <a:defRPr sz="764"/>
            </a:lvl5pPr>
            <a:lvl6pPr marL="1746047" indent="0">
              <a:buNone/>
              <a:defRPr sz="764"/>
            </a:lvl6pPr>
            <a:lvl7pPr marL="2095256" indent="0">
              <a:buNone/>
              <a:defRPr sz="764"/>
            </a:lvl7pPr>
            <a:lvl8pPr marL="2444466" indent="0">
              <a:buNone/>
              <a:defRPr sz="764"/>
            </a:lvl8pPr>
            <a:lvl9pPr marL="2793675" indent="0">
              <a:buNone/>
              <a:defRPr sz="76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E75A-626F-43DC-80CD-FA5F772DBA88}" type="datetimeFigureOut">
              <a:rPr lang="zh-CN" altLang="en-US" smtClean="0"/>
              <a:t>2026/1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43A25-E377-46A9-9087-D4C097D2E4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1507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432" y="361209"/>
            <a:ext cx="3003451" cy="1264232"/>
          </a:xfrm>
        </p:spPr>
        <p:txBody>
          <a:bodyPr anchor="b"/>
          <a:lstStyle>
            <a:lvl1pPr>
              <a:defRPr sz="244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958930" y="780112"/>
            <a:ext cx="4714339" cy="3850390"/>
          </a:xfrm>
        </p:spPr>
        <p:txBody>
          <a:bodyPr anchor="t"/>
          <a:lstStyle>
            <a:lvl1pPr marL="0" indent="0">
              <a:buNone/>
              <a:defRPr sz="2444"/>
            </a:lvl1pPr>
            <a:lvl2pPr marL="349209" indent="0">
              <a:buNone/>
              <a:defRPr sz="2139"/>
            </a:lvl2pPr>
            <a:lvl3pPr marL="698419" indent="0">
              <a:buNone/>
              <a:defRPr sz="1833"/>
            </a:lvl3pPr>
            <a:lvl4pPr marL="1047628" indent="0">
              <a:buNone/>
              <a:defRPr sz="1528"/>
            </a:lvl4pPr>
            <a:lvl5pPr marL="1396837" indent="0">
              <a:buNone/>
              <a:defRPr sz="1528"/>
            </a:lvl5pPr>
            <a:lvl6pPr marL="1746047" indent="0">
              <a:buNone/>
              <a:defRPr sz="1528"/>
            </a:lvl6pPr>
            <a:lvl7pPr marL="2095256" indent="0">
              <a:buNone/>
              <a:defRPr sz="1528"/>
            </a:lvl7pPr>
            <a:lvl8pPr marL="2444466" indent="0">
              <a:buNone/>
              <a:defRPr sz="1528"/>
            </a:lvl8pPr>
            <a:lvl9pPr marL="2793675" indent="0">
              <a:buNone/>
              <a:defRPr sz="1528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1432" y="1625442"/>
            <a:ext cx="3003451" cy="3011331"/>
          </a:xfrm>
        </p:spPr>
        <p:txBody>
          <a:bodyPr/>
          <a:lstStyle>
            <a:lvl1pPr marL="0" indent="0">
              <a:buNone/>
              <a:defRPr sz="1222"/>
            </a:lvl1pPr>
            <a:lvl2pPr marL="349209" indent="0">
              <a:buNone/>
              <a:defRPr sz="1069"/>
            </a:lvl2pPr>
            <a:lvl3pPr marL="698419" indent="0">
              <a:buNone/>
              <a:defRPr sz="917"/>
            </a:lvl3pPr>
            <a:lvl4pPr marL="1047628" indent="0">
              <a:buNone/>
              <a:defRPr sz="764"/>
            </a:lvl4pPr>
            <a:lvl5pPr marL="1396837" indent="0">
              <a:buNone/>
              <a:defRPr sz="764"/>
            </a:lvl5pPr>
            <a:lvl6pPr marL="1746047" indent="0">
              <a:buNone/>
              <a:defRPr sz="764"/>
            </a:lvl6pPr>
            <a:lvl7pPr marL="2095256" indent="0">
              <a:buNone/>
              <a:defRPr sz="764"/>
            </a:lvl7pPr>
            <a:lvl8pPr marL="2444466" indent="0">
              <a:buNone/>
              <a:defRPr sz="764"/>
            </a:lvl8pPr>
            <a:lvl9pPr marL="2793675" indent="0">
              <a:buNone/>
              <a:defRPr sz="76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E75A-626F-43DC-80CD-FA5F772DBA88}" type="datetimeFigureOut">
              <a:rPr lang="zh-CN" altLang="en-US" smtClean="0"/>
              <a:t>2026/1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43A25-E377-46A9-9087-D4C097D2E4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8277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0219" y="288466"/>
            <a:ext cx="8031837" cy="10472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0219" y="1442328"/>
            <a:ext cx="8031837" cy="34377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40219" y="5021811"/>
            <a:ext cx="2095262" cy="28846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FE75A-626F-43DC-80CD-FA5F772DBA88}" type="datetimeFigureOut">
              <a:rPr lang="zh-CN" altLang="en-US" smtClean="0"/>
              <a:t>2026/1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84691" y="5021811"/>
            <a:ext cx="3142893" cy="28846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76794" y="5021811"/>
            <a:ext cx="2095262" cy="28846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F43A25-E377-46A9-9087-D4C097D2E4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6017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98419" rtl="0" eaLnBrk="1" latinLnBrk="0" hangingPunct="1">
        <a:lnSpc>
          <a:spcPct val="90000"/>
        </a:lnSpc>
        <a:spcBef>
          <a:spcPct val="0"/>
        </a:spcBef>
        <a:buNone/>
        <a:defRPr sz="336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4605" indent="-174605" algn="l" defTabSz="698419" rtl="0" eaLnBrk="1" latinLnBrk="0" hangingPunct="1">
        <a:lnSpc>
          <a:spcPct val="90000"/>
        </a:lnSpc>
        <a:spcBef>
          <a:spcPts val="764"/>
        </a:spcBef>
        <a:buFont typeface="Arial" panose="020B0604020202020204" pitchFamily="34" charset="0"/>
        <a:buChar char="•"/>
        <a:defRPr sz="2139" kern="1200">
          <a:solidFill>
            <a:schemeClr val="tx1"/>
          </a:solidFill>
          <a:latin typeface="+mn-lt"/>
          <a:ea typeface="+mn-ea"/>
          <a:cs typeface="+mn-cs"/>
        </a:defRPr>
      </a:lvl1pPr>
      <a:lvl2pPr marL="523814" indent="-174605" algn="l" defTabSz="698419" rtl="0" eaLnBrk="1" latinLnBrk="0" hangingPunct="1">
        <a:lnSpc>
          <a:spcPct val="90000"/>
        </a:lnSpc>
        <a:spcBef>
          <a:spcPts val="382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2pPr>
      <a:lvl3pPr marL="873023" indent="-174605" algn="l" defTabSz="698419" rtl="0" eaLnBrk="1" latinLnBrk="0" hangingPunct="1">
        <a:lnSpc>
          <a:spcPct val="90000"/>
        </a:lnSpc>
        <a:spcBef>
          <a:spcPts val="382"/>
        </a:spcBef>
        <a:buFont typeface="Arial" panose="020B0604020202020204" pitchFamily="34" charset="0"/>
        <a:buChar char="•"/>
        <a:defRPr sz="1528" kern="1200">
          <a:solidFill>
            <a:schemeClr val="tx1"/>
          </a:solidFill>
          <a:latin typeface="+mn-lt"/>
          <a:ea typeface="+mn-ea"/>
          <a:cs typeface="+mn-cs"/>
        </a:defRPr>
      </a:lvl3pPr>
      <a:lvl4pPr marL="1222233" indent="-174605" algn="l" defTabSz="698419" rtl="0" eaLnBrk="1" latinLnBrk="0" hangingPunct="1">
        <a:lnSpc>
          <a:spcPct val="90000"/>
        </a:lnSpc>
        <a:spcBef>
          <a:spcPts val="382"/>
        </a:spcBef>
        <a:buFont typeface="Arial" panose="020B0604020202020204" pitchFamily="34" charset="0"/>
        <a:buChar char="•"/>
        <a:defRPr sz="1375" kern="1200">
          <a:solidFill>
            <a:schemeClr val="tx1"/>
          </a:solidFill>
          <a:latin typeface="+mn-lt"/>
          <a:ea typeface="+mn-ea"/>
          <a:cs typeface="+mn-cs"/>
        </a:defRPr>
      </a:lvl4pPr>
      <a:lvl5pPr marL="1571442" indent="-174605" algn="l" defTabSz="698419" rtl="0" eaLnBrk="1" latinLnBrk="0" hangingPunct="1">
        <a:lnSpc>
          <a:spcPct val="90000"/>
        </a:lnSpc>
        <a:spcBef>
          <a:spcPts val="382"/>
        </a:spcBef>
        <a:buFont typeface="Arial" panose="020B0604020202020204" pitchFamily="34" charset="0"/>
        <a:buChar char="•"/>
        <a:defRPr sz="1375" kern="1200">
          <a:solidFill>
            <a:schemeClr val="tx1"/>
          </a:solidFill>
          <a:latin typeface="+mn-lt"/>
          <a:ea typeface="+mn-ea"/>
          <a:cs typeface="+mn-cs"/>
        </a:defRPr>
      </a:lvl5pPr>
      <a:lvl6pPr marL="1920651" indent="-174605" algn="l" defTabSz="698419" rtl="0" eaLnBrk="1" latinLnBrk="0" hangingPunct="1">
        <a:lnSpc>
          <a:spcPct val="90000"/>
        </a:lnSpc>
        <a:spcBef>
          <a:spcPts val="382"/>
        </a:spcBef>
        <a:buFont typeface="Arial" panose="020B0604020202020204" pitchFamily="34" charset="0"/>
        <a:buChar char="•"/>
        <a:defRPr sz="1375" kern="1200">
          <a:solidFill>
            <a:schemeClr val="tx1"/>
          </a:solidFill>
          <a:latin typeface="+mn-lt"/>
          <a:ea typeface="+mn-ea"/>
          <a:cs typeface="+mn-cs"/>
        </a:defRPr>
      </a:lvl6pPr>
      <a:lvl7pPr marL="2269861" indent="-174605" algn="l" defTabSz="698419" rtl="0" eaLnBrk="1" latinLnBrk="0" hangingPunct="1">
        <a:lnSpc>
          <a:spcPct val="90000"/>
        </a:lnSpc>
        <a:spcBef>
          <a:spcPts val="382"/>
        </a:spcBef>
        <a:buFont typeface="Arial" panose="020B0604020202020204" pitchFamily="34" charset="0"/>
        <a:buChar char="•"/>
        <a:defRPr sz="1375" kern="1200">
          <a:solidFill>
            <a:schemeClr val="tx1"/>
          </a:solidFill>
          <a:latin typeface="+mn-lt"/>
          <a:ea typeface="+mn-ea"/>
          <a:cs typeface="+mn-cs"/>
        </a:defRPr>
      </a:lvl7pPr>
      <a:lvl8pPr marL="2619070" indent="-174605" algn="l" defTabSz="698419" rtl="0" eaLnBrk="1" latinLnBrk="0" hangingPunct="1">
        <a:lnSpc>
          <a:spcPct val="90000"/>
        </a:lnSpc>
        <a:spcBef>
          <a:spcPts val="382"/>
        </a:spcBef>
        <a:buFont typeface="Arial" panose="020B0604020202020204" pitchFamily="34" charset="0"/>
        <a:buChar char="•"/>
        <a:defRPr sz="1375" kern="1200">
          <a:solidFill>
            <a:schemeClr val="tx1"/>
          </a:solidFill>
          <a:latin typeface="+mn-lt"/>
          <a:ea typeface="+mn-ea"/>
          <a:cs typeface="+mn-cs"/>
        </a:defRPr>
      </a:lvl8pPr>
      <a:lvl9pPr marL="2968280" indent="-174605" algn="l" defTabSz="698419" rtl="0" eaLnBrk="1" latinLnBrk="0" hangingPunct="1">
        <a:lnSpc>
          <a:spcPct val="90000"/>
        </a:lnSpc>
        <a:spcBef>
          <a:spcPts val="382"/>
        </a:spcBef>
        <a:buFont typeface="Arial" panose="020B0604020202020204" pitchFamily="34" charset="0"/>
        <a:buChar char="•"/>
        <a:defRPr sz="137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98419" rtl="0" eaLnBrk="1" latinLnBrk="0" hangingPunct="1">
        <a:defRPr sz="1375" kern="1200">
          <a:solidFill>
            <a:schemeClr val="tx1"/>
          </a:solidFill>
          <a:latin typeface="+mn-lt"/>
          <a:ea typeface="+mn-ea"/>
          <a:cs typeface="+mn-cs"/>
        </a:defRPr>
      </a:lvl1pPr>
      <a:lvl2pPr marL="349209" algn="l" defTabSz="698419" rtl="0" eaLnBrk="1" latinLnBrk="0" hangingPunct="1">
        <a:defRPr sz="1375" kern="1200">
          <a:solidFill>
            <a:schemeClr val="tx1"/>
          </a:solidFill>
          <a:latin typeface="+mn-lt"/>
          <a:ea typeface="+mn-ea"/>
          <a:cs typeface="+mn-cs"/>
        </a:defRPr>
      </a:lvl2pPr>
      <a:lvl3pPr marL="698419" algn="l" defTabSz="698419" rtl="0" eaLnBrk="1" latinLnBrk="0" hangingPunct="1">
        <a:defRPr sz="1375" kern="1200">
          <a:solidFill>
            <a:schemeClr val="tx1"/>
          </a:solidFill>
          <a:latin typeface="+mn-lt"/>
          <a:ea typeface="+mn-ea"/>
          <a:cs typeface="+mn-cs"/>
        </a:defRPr>
      </a:lvl3pPr>
      <a:lvl4pPr marL="1047628" algn="l" defTabSz="698419" rtl="0" eaLnBrk="1" latinLnBrk="0" hangingPunct="1">
        <a:defRPr sz="1375" kern="1200">
          <a:solidFill>
            <a:schemeClr val="tx1"/>
          </a:solidFill>
          <a:latin typeface="+mn-lt"/>
          <a:ea typeface="+mn-ea"/>
          <a:cs typeface="+mn-cs"/>
        </a:defRPr>
      </a:lvl4pPr>
      <a:lvl5pPr marL="1396837" algn="l" defTabSz="698419" rtl="0" eaLnBrk="1" latinLnBrk="0" hangingPunct="1">
        <a:defRPr sz="1375" kern="1200">
          <a:solidFill>
            <a:schemeClr val="tx1"/>
          </a:solidFill>
          <a:latin typeface="+mn-lt"/>
          <a:ea typeface="+mn-ea"/>
          <a:cs typeface="+mn-cs"/>
        </a:defRPr>
      </a:lvl5pPr>
      <a:lvl6pPr marL="1746047" algn="l" defTabSz="698419" rtl="0" eaLnBrk="1" latinLnBrk="0" hangingPunct="1">
        <a:defRPr sz="1375" kern="1200">
          <a:solidFill>
            <a:schemeClr val="tx1"/>
          </a:solidFill>
          <a:latin typeface="+mn-lt"/>
          <a:ea typeface="+mn-ea"/>
          <a:cs typeface="+mn-cs"/>
        </a:defRPr>
      </a:lvl6pPr>
      <a:lvl7pPr marL="2095256" algn="l" defTabSz="698419" rtl="0" eaLnBrk="1" latinLnBrk="0" hangingPunct="1">
        <a:defRPr sz="1375" kern="1200">
          <a:solidFill>
            <a:schemeClr val="tx1"/>
          </a:solidFill>
          <a:latin typeface="+mn-lt"/>
          <a:ea typeface="+mn-ea"/>
          <a:cs typeface="+mn-cs"/>
        </a:defRPr>
      </a:lvl7pPr>
      <a:lvl8pPr marL="2444466" algn="l" defTabSz="698419" rtl="0" eaLnBrk="1" latinLnBrk="0" hangingPunct="1">
        <a:defRPr sz="1375" kern="1200">
          <a:solidFill>
            <a:schemeClr val="tx1"/>
          </a:solidFill>
          <a:latin typeface="+mn-lt"/>
          <a:ea typeface="+mn-ea"/>
          <a:cs typeface="+mn-cs"/>
        </a:defRPr>
      </a:lvl8pPr>
      <a:lvl9pPr marL="2793675" algn="l" defTabSz="698419" rtl="0" eaLnBrk="1" latinLnBrk="0" hangingPunct="1">
        <a:defRPr sz="137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/>
          <p:cNvSpPr txBox="1"/>
          <p:nvPr/>
        </p:nvSpPr>
        <p:spPr>
          <a:xfrm>
            <a:off x="600253" y="1289546"/>
            <a:ext cx="615899" cy="2685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45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14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4656137" y="1294633"/>
            <a:ext cx="615898" cy="2685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45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14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155819" y="4446018"/>
            <a:ext cx="6987932" cy="8891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. S1 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ngle nucleotide polymorphism (SNP) distribution and classification.</a:t>
            </a:r>
            <a:r>
              <a:rPr lang="en-US" altLang="zh-CN" sz="1200" kern="1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</a:t>
            </a:r>
            <a:r>
              <a:rPr lang="en-US" altLang="zh-CN" sz="1200" b="1" kern="1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A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Genic distribution of SNPs. Exon, Expressed region. </a:t>
            </a:r>
            <a:r>
              <a:rPr lang="en-US" altLang="zh-CN" sz="1200" b="1" kern="1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B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Distribution of SNP types among those within the coding sequence (CDS). SNV, Single nucleotide variants.</a:t>
            </a:r>
            <a:endParaRPr lang="zh-CN" altLang="zh-CN" sz="1200" kern="1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" name="图片 2" descr="图表, 条形图&#10;&#10;描述已自动生成">
            <a:extLst>
              <a:ext uri="{FF2B5EF4-FFF2-40B4-BE49-F238E27FC236}">
                <a16:creationId xmlns:a16="http://schemas.microsoft.com/office/drawing/2014/main" id="{1D77003F-9EA0-444A-8FB7-FD1175D5EC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222" y="1563168"/>
            <a:ext cx="3657917" cy="2408129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D075AA5-42F4-48A1-9D1A-4A0661BAFF4C}"/>
              </a:ext>
            </a:extLst>
          </p:cNvPr>
          <p:cNvSpPr txBox="1"/>
          <p:nvPr/>
        </p:nvSpPr>
        <p:spPr>
          <a:xfrm>
            <a:off x="735885" y="1607659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e+0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AA92ECE-60DF-4B18-96A1-AEFAA36706A9}"/>
              </a:ext>
            </a:extLst>
          </p:cNvPr>
          <p:cNvSpPr txBox="1"/>
          <p:nvPr/>
        </p:nvSpPr>
        <p:spPr>
          <a:xfrm>
            <a:off x="735885" y="2090703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e+0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49B443E-3A22-41FD-A096-E03AC05AFA36}"/>
              </a:ext>
            </a:extLst>
          </p:cNvPr>
          <p:cNvSpPr txBox="1"/>
          <p:nvPr/>
        </p:nvSpPr>
        <p:spPr>
          <a:xfrm>
            <a:off x="735885" y="2583273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e+0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37E621C-54D5-4B6D-BE9A-824C6823D167}"/>
              </a:ext>
            </a:extLst>
          </p:cNvPr>
          <p:cNvSpPr txBox="1"/>
          <p:nvPr/>
        </p:nvSpPr>
        <p:spPr>
          <a:xfrm>
            <a:off x="740647" y="3067252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e+0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371625B-B3F3-4FE8-AB7A-6C4F11CEAB68}"/>
              </a:ext>
            </a:extLst>
          </p:cNvPr>
          <p:cNvSpPr txBox="1"/>
          <p:nvPr/>
        </p:nvSpPr>
        <p:spPr>
          <a:xfrm>
            <a:off x="735885" y="3559822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e+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0D6D33C-340B-4D04-97A6-731FFEE3EC73}"/>
              </a:ext>
            </a:extLst>
          </p:cNvPr>
          <p:cNvSpPr txBox="1"/>
          <p:nvPr/>
        </p:nvSpPr>
        <p:spPr>
          <a:xfrm>
            <a:off x="1239284" y="3771826"/>
            <a:ext cx="6403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ntergeni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28229C9-EF2A-4186-A190-B73C68EAF1CD}"/>
              </a:ext>
            </a:extLst>
          </p:cNvPr>
          <p:cNvSpPr txBox="1"/>
          <p:nvPr/>
        </p:nvSpPr>
        <p:spPr>
          <a:xfrm>
            <a:off x="1982233" y="3776540"/>
            <a:ext cx="4307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041FBE7-D31C-46CE-B3A0-DB08C1A917BB}"/>
              </a:ext>
            </a:extLst>
          </p:cNvPr>
          <p:cNvSpPr txBox="1"/>
          <p:nvPr/>
        </p:nvSpPr>
        <p:spPr>
          <a:xfrm>
            <a:off x="2635780" y="3769660"/>
            <a:ext cx="4820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ntro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621D6C1-9001-4DD0-B116-577A73C58F96}"/>
              </a:ext>
            </a:extLst>
          </p:cNvPr>
          <p:cNvSpPr txBox="1"/>
          <p:nvPr/>
        </p:nvSpPr>
        <p:spPr>
          <a:xfrm>
            <a:off x="3251727" y="3776010"/>
            <a:ext cx="571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plicing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B243BF5-A84E-407A-A966-D996B7CF4678}"/>
              </a:ext>
            </a:extLst>
          </p:cNvPr>
          <p:cNvSpPr txBox="1"/>
          <p:nvPr/>
        </p:nvSpPr>
        <p:spPr>
          <a:xfrm>
            <a:off x="2350293" y="3979529"/>
            <a:ext cx="4820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Typ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4C7280B-4EAD-40A7-B967-F6075FEFF0DF}"/>
              </a:ext>
            </a:extLst>
          </p:cNvPr>
          <p:cNvSpPr txBox="1"/>
          <p:nvPr/>
        </p:nvSpPr>
        <p:spPr>
          <a:xfrm rot="16200000">
            <a:off x="9851" y="2544386"/>
            <a:ext cx="13853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Number of variants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D8B209BE-F40C-421D-A54A-F259BD198D25}"/>
              </a:ext>
            </a:extLst>
          </p:cNvPr>
          <p:cNvSpPr txBox="1"/>
          <p:nvPr/>
        </p:nvSpPr>
        <p:spPr>
          <a:xfrm>
            <a:off x="4080184" y="2554143"/>
            <a:ext cx="6403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ntergeni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E1F03DD9-0A09-4066-8871-6B5EDA0C25EE}"/>
              </a:ext>
            </a:extLst>
          </p:cNvPr>
          <p:cNvSpPr txBox="1"/>
          <p:nvPr/>
        </p:nvSpPr>
        <p:spPr>
          <a:xfrm>
            <a:off x="4080495" y="2445314"/>
            <a:ext cx="4307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DDF3E22D-A9D9-4217-9557-FD2A7BE61027}"/>
              </a:ext>
            </a:extLst>
          </p:cNvPr>
          <p:cNvSpPr txBox="1"/>
          <p:nvPr/>
        </p:nvSpPr>
        <p:spPr>
          <a:xfrm>
            <a:off x="4080184" y="2678212"/>
            <a:ext cx="4820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ntro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28413325-C617-4937-A79B-7D9EB7A77A48}"/>
              </a:ext>
            </a:extLst>
          </p:cNvPr>
          <p:cNvSpPr txBox="1"/>
          <p:nvPr/>
        </p:nvSpPr>
        <p:spPr>
          <a:xfrm>
            <a:off x="4078285" y="2800271"/>
            <a:ext cx="571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plicing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 descr="图表, 条形图&#10;&#10;描述已自动生成">
            <a:extLst>
              <a:ext uri="{FF2B5EF4-FFF2-40B4-BE49-F238E27FC236}">
                <a16:creationId xmlns:a16="http://schemas.microsoft.com/office/drawing/2014/main" id="{8A309307-26FC-421C-95B6-19AA1B50B06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7538" y="1505004"/>
            <a:ext cx="3574090" cy="2408129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DAEF0043-3D87-4C87-B189-848B07F74911}"/>
              </a:ext>
            </a:extLst>
          </p:cNvPr>
          <p:cNvSpPr txBox="1"/>
          <p:nvPr/>
        </p:nvSpPr>
        <p:spPr>
          <a:xfrm rot="16200000">
            <a:off x="4196415" y="2483303"/>
            <a:ext cx="13853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Number of variants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0958DA4B-65DF-42CD-BFAA-7834E6CB1039}"/>
              </a:ext>
            </a:extLst>
          </p:cNvPr>
          <p:cNvSpPr txBox="1"/>
          <p:nvPr/>
        </p:nvSpPr>
        <p:spPr>
          <a:xfrm>
            <a:off x="4879454" y="1749916"/>
            <a:ext cx="5355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0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13E033A1-35BC-49FB-B80C-514B6DAC6099}"/>
              </a:ext>
            </a:extLst>
          </p:cNvPr>
          <p:cNvSpPr txBox="1"/>
          <p:nvPr/>
        </p:nvSpPr>
        <p:spPr>
          <a:xfrm>
            <a:off x="4882432" y="2336688"/>
            <a:ext cx="5355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0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B7B8EC44-55BE-429D-A0DA-0C8C27987618}"/>
              </a:ext>
            </a:extLst>
          </p:cNvPr>
          <p:cNvSpPr txBox="1"/>
          <p:nvPr/>
        </p:nvSpPr>
        <p:spPr>
          <a:xfrm>
            <a:off x="4935824" y="2919285"/>
            <a:ext cx="5355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0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4473059C-6A51-44C4-940E-C786DE915F86}"/>
              </a:ext>
            </a:extLst>
          </p:cNvPr>
          <p:cNvSpPr txBox="1"/>
          <p:nvPr/>
        </p:nvSpPr>
        <p:spPr>
          <a:xfrm>
            <a:off x="5167241" y="3512079"/>
            <a:ext cx="5355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873CD83F-2318-4586-981F-E00CC5EA9C33}"/>
              </a:ext>
            </a:extLst>
          </p:cNvPr>
          <p:cNvSpPr txBox="1"/>
          <p:nvPr/>
        </p:nvSpPr>
        <p:spPr>
          <a:xfrm rot="20368284">
            <a:off x="4648720" y="3875263"/>
            <a:ext cx="12232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onsynonymous-SNV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D3FC30DC-8D5D-4B33-A5FA-55C86E4862A7}"/>
              </a:ext>
            </a:extLst>
          </p:cNvPr>
          <p:cNvSpPr txBox="1"/>
          <p:nvPr/>
        </p:nvSpPr>
        <p:spPr>
          <a:xfrm rot="20368284">
            <a:off x="5345432" y="3819912"/>
            <a:ext cx="12232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ynonymous-SNV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D272ADF-3BAE-43C7-8797-0A0E74E3E956}"/>
              </a:ext>
            </a:extLst>
          </p:cNvPr>
          <p:cNvSpPr txBox="1"/>
          <p:nvPr/>
        </p:nvSpPr>
        <p:spPr>
          <a:xfrm>
            <a:off x="6497729" y="3713919"/>
            <a:ext cx="60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Stopga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0BAF18F1-6808-47A1-9CEA-B21C141025C6}"/>
              </a:ext>
            </a:extLst>
          </p:cNvPr>
          <p:cNvSpPr txBox="1"/>
          <p:nvPr/>
        </p:nvSpPr>
        <p:spPr>
          <a:xfrm>
            <a:off x="7075060" y="3715563"/>
            <a:ext cx="60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toploss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912FCDC1-D6A1-4805-85F0-E0EF24CC9205}"/>
              </a:ext>
            </a:extLst>
          </p:cNvPr>
          <p:cNvSpPr txBox="1"/>
          <p:nvPr/>
        </p:nvSpPr>
        <p:spPr>
          <a:xfrm>
            <a:off x="7866025" y="2407168"/>
            <a:ext cx="12232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onsynonymous-SNV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DD2438FF-9610-4942-952B-29999857A09E}"/>
              </a:ext>
            </a:extLst>
          </p:cNvPr>
          <p:cNvSpPr txBox="1"/>
          <p:nvPr/>
        </p:nvSpPr>
        <p:spPr>
          <a:xfrm>
            <a:off x="7871356" y="2764229"/>
            <a:ext cx="12232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ynonymous-SNV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F6E4CAC6-3E30-4EBA-ADF1-E4E615CEB613}"/>
              </a:ext>
            </a:extLst>
          </p:cNvPr>
          <p:cNvSpPr txBox="1"/>
          <p:nvPr/>
        </p:nvSpPr>
        <p:spPr>
          <a:xfrm>
            <a:off x="7869037" y="2529251"/>
            <a:ext cx="60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Stopga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06E546E1-5B5E-4257-A79B-7387CB14F9EB}"/>
              </a:ext>
            </a:extLst>
          </p:cNvPr>
          <p:cNvSpPr txBox="1"/>
          <p:nvPr/>
        </p:nvSpPr>
        <p:spPr>
          <a:xfrm>
            <a:off x="7870531" y="2646812"/>
            <a:ext cx="60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toploss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2BC3B9F9-B0AE-43A5-BD77-59751EC90B8F}"/>
              </a:ext>
            </a:extLst>
          </p:cNvPr>
          <p:cNvSpPr txBox="1"/>
          <p:nvPr/>
        </p:nvSpPr>
        <p:spPr>
          <a:xfrm>
            <a:off x="6296390" y="4052135"/>
            <a:ext cx="4820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Typ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617193" y="4229171"/>
            <a:ext cx="8001000" cy="14431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. S2</a:t>
            </a:r>
            <a:r>
              <a:rPr lang="zh-CN" alt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ssignment of isolates to genotype clusters using STRUCTURE. </a:t>
            </a:r>
            <a:r>
              <a:rPr lang="en-US" altLang="zh-CN" sz="12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Delta K (K = 2–9)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distributionbased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on the </a:t>
            </a:r>
            <a:r>
              <a:rPr lang="en-US" altLang="zh-CN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Evanno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method. The maximum Delta K value corresponds to the optimal cluster number. </a:t>
            </a:r>
            <a:r>
              <a:rPr lang="en-US" altLang="zh-CN" sz="12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Predicted isolate distribution among K clusters (represented by color). 21GS, 2021 Gansu; 21NX, 2021 Ningxia; 21QH, 2021 Qinghai; 22GS, 2022 Gansu; 22NX, 2022 Ningxia; 22QH, 2022 Qinghai.</a:t>
            </a:r>
            <a:endParaRPr lang="zh-CN" altLang="zh-CN" sz="1200" kern="1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3819023" y="666079"/>
            <a:ext cx="4235002" cy="3544352"/>
            <a:chOff x="2331" y="289"/>
            <a:chExt cx="13961" cy="10506"/>
          </a:xfrm>
        </p:grpSpPr>
        <p:grpSp>
          <p:nvGrpSpPr>
            <p:cNvPr id="7" name="组合 6"/>
            <p:cNvGrpSpPr/>
            <p:nvPr/>
          </p:nvGrpSpPr>
          <p:grpSpPr>
            <a:xfrm>
              <a:off x="2700" y="9782"/>
              <a:ext cx="12343" cy="1013"/>
              <a:chOff x="612727" y="4622853"/>
              <a:chExt cx="6031698" cy="558399"/>
            </a:xfrm>
          </p:grpSpPr>
          <p:sp>
            <p:nvSpPr>
              <p:cNvPr id="28" name="左大括号 27"/>
              <p:cNvSpPr/>
              <p:nvPr/>
            </p:nvSpPr>
            <p:spPr>
              <a:xfrm rot="16200000">
                <a:off x="1099683" y="4135899"/>
                <a:ext cx="132385" cy="1106297"/>
              </a:xfrm>
              <a:prstGeom prst="leftBrace">
                <a:avLst>
                  <a:gd name="adj1" fmla="val 8333"/>
                  <a:gd name="adj2" fmla="val 49123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779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endParaRPr>
              </a:p>
            </p:txBody>
          </p:sp>
          <p:sp>
            <p:nvSpPr>
              <p:cNvPr id="29" name="左大括号 28"/>
              <p:cNvSpPr/>
              <p:nvPr/>
            </p:nvSpPr>
            <p:spPr>
              <a:xfrm rot="16200000">
                <a:off x="1913311" y="4428568"/>
                <a:ext cx="132385" cy="520960"/>
              </a:xfrm>
              <a:prstGeom prst="leftBrace">
                <a:avLst>
                  <a:gd name="adj1" fmla="val 8333"/>
                  <a:gd name="adj2" fmla="val 49123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779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endParaRPr>
              </a:p>
            </p:txBody>
          </p:sp>
          <p:sp>
            <p:nvSpPr>
              <p:cNvPr id="30" name="左大括号 29"/>
              <p:cNvSpPr/>
              <p:nvPr/>
            </p:nvSpPr>
            <p:spPr>
              <a:xfrm rot="16200000">
                <a:off x="3063280" y="3791922"/>
                <a:ext cx="132385" cy="1794250"/>
              </a:xfrm>
              <a:prstGeom prst="leftBrace">
                <a:avLst>
                  <a:gd name="adj1" fmla="val 8333"/>
                  <a:gd name="adj2" fmla="val 49123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779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endParaRPr>
              </a:p>
            </p:txBody>
          </p:sp>
          <p:sp>
            <p:nvSpPr>
              <p:cNvPr id="31" name="左大括号 30"/>
              <p:cNvSpPr/>
              <p:nvPr/>
            </p:nvSpPr>
            <p:spPr>
              <a:xfrm rot="16200000">
                <a:off x="4686824" y="3974405"/>
                <a:ext cx="132386" cy="1429283"/>
              </a:xfrm>
              <a:prstGeom prst="leftBrace">
                <a:avLst>
                  <a:gd name="adj1" fmla="val 8333"/>
                  <a:gd name="adj2" fmla="val 49123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779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endParaRPr>
              </a:p>
            </p:txBody>
          </p:sp>
          <p:sp>
            <p:nvSpPr>
              <p:cNvPr id="32" name="左大括号 31"/>
              <p:cNvSpPr/>
              <p:nvPr/>
            </p:nvSpPr>
            <p:spPr>
              <a:xfrm rot="16200000">
                <a:off x="5956792" y="4378602"/>
                <a:ext cx="138818" cy="627322"/>
              </a:xfrm>
              <a:prstGeom prst="leftBrace">
                <a:avLst>
                  <a:gd name="adj1" fmla="val 8333"/>
                  <a:gd name="adj2" fmla="val 49123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779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endParaRPr>
              </a:p>
            </p:txBody>
          </p:sp>
          <p:sp>
            <p:nvSpPr>
              <p:cNvPr id="33" name="文本框 32"/>
              <p:cNvSpPr txBox="1"/>
              <p:nvPr/>
            </p:nvSpPr>
            <p:spPr>
              <a:xfrm>
                <a:off x="734615" y="4773718"/>
                <a:ext cx="862518" cy="4024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1GS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/>
              <p:cNvSpPr txBox="1"/>
              <p:nvPr/>
            </p:nvSpPr>
            <p:spPr>
              <a:xfrm>
                <a:off x="1570896" y="4772747"/>
                <a:ext cx="816159" cy="4026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1NX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文本框 34"/>
              <p:cNvSpPr txBox="1"/>
              <p:nvPr/>
            </p:nvSpPr>
            <p:spPr>
              <a:xfrm>
                <a:off x="2693344" y="4778642"/>
                <a:ext cx="849496" cy="402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1QH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文本框 35"/>
              <p:cNvSpPr txBox="1"/>
              <p:nvPr/>
            </p:nvSpPr>
            <p:spPr>
              <a:xfrm>
                <a:off x="4317415" y="4777937"/>
                <a:ext cx="862513" cy="4023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2GS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左大括号 36"/>
              <p:cNvSpPr/>
              <p:nvPr/>
            </p:nvSpPr>
            <p:spPr>
              <a:xfrm rot="16200000">
                <a:off x="5529797" y="4572494"/>
                <a:ext cx="132386" cy="233104"/>
              </a:xfrm>
              <a:prstGeom prst="leftBrace">
                <a:avLst>
                  <a:gd name="adj1" fmla="val 8333"/>
                  <a:gd name="adj2" fmla="val 49123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779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endParaRPr>
              </a:p>
            </p:txBody>
          </p:sp>
          <p:sp>
            <p:nvSpPr>
              <p:cNvPr id="38" name="文本框 37"/>
              <p:cNvSpPr txBox="1"/>
              <p:nvPr/>
            </p:nvSpPr>
            <p:spPr>
              <a:xfrm>
                <a:off x="5155212" y="4772749"/>
                <a:ext cx="813188" cy="4024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2NX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文本框 38"/>
              <p:cNvSpPr txBox="1"/>
              <p:nvPr/>
            </p:nvSpPr>
            <p:spPr>
              <a:xfrm>
                <a:off x="5760232" y="4777937"/>
                <a:ext cx="884193" cy="4023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2QH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组合 7"/>
            <p:cNvGrpSpPr/>
            <p:nvPr/>
          </p:nvGrpSpPr>
          <p:grpSpPr>
            <a:xfrm>
              <a:off x="2331" y="289"/>
              <a:ext cx="13961" cy="9455"/>
              <a:chOff x="2331" y="289"/>
              <a:chExt cx="13961" cy="9455"/>
            </a:xfrm>
          </p:grpSpPr>
          <p:grpSp>
            <p:nvGrpSpPr>
              <p:cNvPr id="9" name="组合 8"/>
              <p:cNvGrpSpPr/>
              <p:nvPr/>
            </p:nvGrpSpPr>
            <p:grpSpPr>
              <a:xfrm>
                <a:off x="2331" y="289"/>
                <a:ext cx="13961" cy="8235"/>
                <a:chOff x="417082" y="-44432"/>
                <a:chExt cx="8318569" cy="6166289"/>
              </a:xfrm>
            </p:grpSpPr>
            <p:grpSp>
              <p:nvGrpSpPr>
                <p:cNvPr id="13" name="组合 12"/>
                <p:cNvGrpSpPr/>
                <p:nvPr/>
              </p:nvGrpSpPr>
              <p:grpSpPr>
                <a:xfrm>
                  <a:off x="417082" y="-44432"/>
                  <a:ext cx="8229637" cy="2434787"/>
                  <a:chOff x="456157" y="1946210"/>
                  <a:chExt cx="8219729" cy="4303373"/>
                </a:xfrm>
              </p:grpSpPr>
              <p:sp>
                <p:nvSpPr>
                  <p:cNvPr id="21" name="文本框 20"/>
                  <p:cNvSpPr txBox="1"/>
                  <p:nvPr/>
                </p:nvSpPr>
                <p:spPr>
                  <a:xfrm>
                    <a:off x="7687149" y="2239989"/>
                    <a:ext cx="973433" cy="96590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=2</a:t>
                    </a:r>
                    <a:endParaRPr lang="zh-CN" alt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" name="文本框 21"/>
                  <p:cNvSpPr txBox="1"/>
                  <p:nvPr/>
                </p:nvSpPr>
                <p:spPr>
                  <a:xfrm>
                    <a:off x="7666139" y="3761518"/>
                    <a:ext cx="994442" cy="96590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=3</a:t>
                    </a:r>
                    <a:endParaRPr lang="zh-CN" alt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" name="文本框 22"/>
                  <p:cNvSpPr txBox="1"/>
                  <p:nvPr/>
                </p:nvSpPr>
                <p:spPr>
                  <a:xfrm>
                    <a:off x="7681446" y="5197987"/>
                    <a:ext cx="994440" cy="96590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=4</a:t>
                    </a:r>
                    <a:endParaRPr lang="zh-CN" alt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24" name="图片 23"/>
                  <p:cNvPicPr>
                    <a:picLocks noChangeAspect="1"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657336" y="3440074"/>
                    <a:ext cx="7059620" cy="1402007"/>
                  </a:xfrm>
                  <a:prstGeom prst="rect">
                    <a:avLst/>
                  </a:prstGeom>
                </p:spPr>
              </p:pic>
              <p:pic>
                <p:nvPicPr>
                  <p:cNvPr id="25" name="图片 24"/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456157" y="1946210"/>
                    <a:ext cx="171394" cy="1494116"/>
                  </a:xfrm>
                  <a:prstGeom prst="rect">
                    <a:avLst/>
                  </a:prstGeom>
                </p:spPr>
              </p:pic>
              <p:pic>
                <p:nvPicPr>
                  <p:cNvPr id="26" name="图片 25"/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671523" y="1988387"/>
                    <a:ext cx="7035562" cy="1432702"/>
                  </a:xfrm>
                  <a:prstGeom prst="rect">
                    <a:avLst/>
                  </a:prstGeom>
                </p:spPr>
              </p:pic>
              <p:pic>
                <p:nvPicPr>
                  <p:cNvPr id="27" name="图片 26"/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676322" y="4876677"/>
                    <a:ext cx="7040634" cy="1372906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14" name="图片 13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627630" y="2412452"/>
                  <a:ext cx="7049121" cy="957765"/>
                </a:xfrm>
                <a:prstGeom prst="rect">
                  <a:avLst/>
                </a:prstGeom>
              </p:spPr>
            </p:pic>
            <p:pic>
              <p:nvPicPr>
                <p:cNvPr id="15" name="图片 14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607744" y="3338840"/>
                  <a:ext cx="7069006" cy="953209"/>
                </a:xfrm>
                <a:prstGeom prst="rect">
                  <a:avLst/>
                </a:prstGeom>
              </p:spPr>
            </p:pic>
            <p:pic>
              <p:nvPicPr>
                <p:cNvPr id="16" name="图片 15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607514" y="4305492"/>
                  <a:ext cx="7069236" cy="912946"/>
                </a:xfrm>
                <a:prstGeom prst="rect">
                  <a:avLst/>
                </a:prstGeom>
              </p:spPr>
            </p:pic>
            <p:sp>
              <p:nvSpPr>
                <p:cNvPr id="17" name="文本框 16"/>
                <p:cNvSpPr txBox="1"/>
                <p:nvPr/>
              </p:nvSpPr>
              <p:spPr>
                <a:xfrm>
                  <a:off x="7657771" y="2618208"/>
                  <a:ext cx="973624" cy="5464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=5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文本框 17"/>
                <p:cNvSpPr txBox="1"/>
                <p:nvPr/>
              </p:nvSpPr>
              <p:spPr>
                <a:xfrm>
                  <a:off x="7657773" y="3563202"/>
                  <a:ext cx="988947" cy="5464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=6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文本框 18"/>
                <p:cNvSpPr txBox="1"/>
                <p:nvPr/>
              </p:nvSpPr>
              <p:spPr>
                <a:xfrm>
                  <a:off x="7657773" y="4507578"/>
                  <a:ext cx="1077878" cy="5464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=7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20" name="图片 19"/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616410" y="5238750"/>
                  <a:ext cx="7041355" cy="883107"/>
                </a:xfrm>
                <a:prstGeom prst="rect">
                  <a:avLst/>
                </a:prstGeom>
              </p:spPr>
            </p:pic>
          </p:grpSp>
          <p:sp>
            <p:nvSpPr>
              <p:cNvPr id="10" name="文本框 9"/>
              <p:cNvSpPr txBox="1"/>
              <p:nvPr/>
            </p:nvSpPr>
            <p:spPr>
              <a:xfrm>
                <a:off x="14515" y="7560"/>
                <a:ext cx="1628" cy="7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=8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14515" y="8788"/>
                <a:ext cx="1777" cy="7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=9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2" name="图片 11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661" y="8537"/>
                <a:ext cx="11832" cy="1207"/>
              </a:xfrm>
              <a:prstGeom prst="rect">
                <a:avLst/>
              </a:prstGeom>
            </p:spPr>
          </p:pic>
        </p:grpSp>
      </p:grpSp>
      <p:sp>
        <p:nvSpPr>
          <p:cNvPr id="40" name="文本框 39"/>
          <p:cNvSpPr txBox="1"/>
          <p:nvPr/>
        </p:nvSpPr>
        <p:spPr>
          <a:xfrm>
            <a:off x="801913" y="572716"/>
            <a:ext cx="905914" cy="2685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zh-CN" sz="1145" b="1" dirty="0"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</a:t>
            </a:r>
            <a:endParaRPr lang="zh-CN" altLang="en-US" sz="1145" dirty="0">
              <a:solidFill>
                <a:prstClr val="black"/>
              </a:solidFill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3525160" y="553666"/>
            <a:ext cx="658426" cy="2685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zh-CN" sz="1145" b="1" dirty="0">
                <a:solidFill>
                  <a:srgbClr val="000000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B</a:t>
            </a:r>
            <a:endParaRPr lang="zh-CN" altLang="en-US" sz="1145" dirty="0">
              <a:solidFill>
                <a:prstClr val="black"/>
              </a:solidFill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pic>
        <p:nvPicPr>
          <p:cNvPr id="3" name="图片 2" descr="图表&#10;&#10;描述已自动生成">
            <a:extLst>
              <a:ext uri="{FF2B5EF4-FFF2-40B4-BE49-F238E27FC236}">
                <a16:creationId xmlns:a16="http://schemas.microsoft.com/office/drawing/2014/main" id="{E1279FE8-B7A7-4610-BDB8-47A2AC72892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4326" y="767724"/>
            <a:ext cx="2822284" cy="2297352"/>
          </a:xfrm>
          <a:prstGeom prst="rect">
            <a:avLst/>
          </a:prstGeom>
        </p:spPr>
      </p:pic>
      <p:sp>
        <p:nvSpPr>
          <p:cNvPr id="42" name="文本框 41">
            <a:extLst>
              <a:ext uri="{FF2B5EF4-FFF2-40B4-BE49-F238E27FC236}">
                <a16:creationId xmlns:a16="http://schemas.microsoft.com/office/drawing/2014/main" id="{110EE048-5C7E-403B-9007-B9D538865FA3}"/>
              </a:ext>
            </a:extLst>
          </p:cNvPr>
          <p:cNvSpPr txBox="1"/>
          <p:nvPr/>
        </p:nvSpPr>
        <p:spPr>
          <a:xfrm>
            <a:off x="930304" y="855451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217B41E2-E47E-4339-837B-7BA84BE9332C}"/>
              </a:ext>
            </a:extLst>
          </p:cNvPr>
          <p:cNvSpPr txBox="1"/>
          <p:nvPr/>
        </p:nvSpPr>
        <p:spPr>
          <a:xfrm>
            <a:off x="931951" y="1211733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12096AED-925E-4BA2-B45A-81E43CB8EE43}"/>
              </a:ext>
            </a:extLst>
          </p:cNvPr>
          <p:cNvSpPr txBox="1"/>
          <p:nvPr/>
        </p:nvSpPr>
        <p:spPr>
          <a:xfrm>
            <a:off x="943004" y="1569853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E2744B89-C617-450B-B119-AC8CE6A558E1}"/>
              </a:ext>
            </a:extLst>
          </p:cNvPr>
          <p:cNvSpPr txBox="1"/>
          <p:nvPr/>
        </p:nvSpPr>
        <p:spPr>
          <a:xfrm>
            <a:off x="943032" y="1921870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B0D6EAE7-D3A5-45E7-AC2D-320092BD94B4}"/>
              </a:ext>
            </a:extLst>
          </p:cNvPr>
          <p:cNvSpPr txBox="1"/>
          <p:nvPr/>
        </p:nvSpPr>
        <p:spPr>
          <a:xfrm>
            <a:off x="943032" y="2278354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95F88159-F0B2-4EBA-B3B8-99B28B21AF1F}"/>
              </a:ext>
            </a:extLst>
          </p:cNvPr>
          <p:cNvSpPr txBox="1"/>
          <p:nvPr/>
        </p:nvSpPr>
        <p:spPr>
          <a:xfrm>
            <a:off x="1057332" y="2633533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66D7DF0F-F0BE-493B-8785-D4756C8F4457}"/>
              </a:ext>
            </a:extLst>
          </p:cNvPr>
          <p:cNvSpPr txBox="1"/>
          <p:nvPr/>
        </p:nvSpPr>
        <p:spPr>
          <a:xfrm rot="16200000">
            <a:off x="579706" y="1665777"/>
            <a:ext cx="6422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Delta K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6B725A91-56D5-48E8-83E5-5648E06CCE53}"/>
              </a:ext>
            </a:extLst>
          </p:cNvPr>
          <p:cNvSpPr txBox="1"/>
          <p:nvPr/>
        </p:nvSpPr>
        <p:spPr>
          <a:xfrm>
            <a:off x="1487278" y="2812275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4D31DB13-C7B8-4E19-B67E-23BC5E771368}"/>
              </a:ext>
            </a:extLst>
          </p:cNvPr>
          <p:cNvSpPr txBox="1"/>
          <p:nvPr/>
        </p:nvSpPr>
        <p:spPr>
          <a:xfrm>
            <a:off x="1740143" y="2814193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5B7FE1F9-AD7F-4D15-90AA-EB95C41FF182}"/>
              </a:ext>
            </a:extLst>
          </p:cNvPr>
          <p:cNvSpPr txBox="1"/>
          <p:nvPr/>
        </p:nvSpPr>
        <p:spPr>
          <a:xfrm>
            <a:off x="1990744" y="2817854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8AE2ABAC-418B-40E7-8432-D83722B74185}"/>
              </a:ext>
            </a:extLst>
          </p:cNvPr>
          <p:cNvSpPr txBox="1"/>
          <p:nvPr/>
        </p:nvSpPr>
        <p:spPr>
          <a:xfrm>
            <a:off x="2241888" y="2819456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0461CFC0-E193-45D4-B0D9-5BED3B72E888}"/>
              </a:ext>
            </a:extLst>
          </p:cNvPr>
          <p:cNvSpPr txBox="1"/>
          <p:nvPr/>
        </p:nvSpPr>
        <p:spPr>
          <a:xfrm>
            <a:off x="2495596" y="2816281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322DB3C9-1018-4FD1-ABB5-23373A729D4E}"/>
              </a:ext>
            </a:extLst>
          </p:cNvPr>
          <p:cNvSpPr txBox="1"/>
          <p:nvPr/>
        </p:nvSpPr>
        <p:spPr>
          <a:xfrm>
            <a:off x="2749304" y="2816281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2E014050-2B8E-494C-B431-90D18A0FBEEB}"/>
              </a:ext>
            </a:extLst>
          </p:cNvPr>
          <p:cNvSpPr txBox="1"/>
          <p:nvPr/>
        </p:nvSpPr>
        <p:spPr>
          <a:xfrm>
            <a:off x="2997637" y="2813748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675A64AF-DBA6-4947-A922-A9134F19C14B}"/>
              </a:ext>
            </a:extLst>
          </p:cNvPr>
          <p:cNvSpPr txBox="1"/>
          <p:nvPr/>
        </p:nvSpPr>
        <p:spPr>
          <a:xfrm>
            <a:off x="3253394" y="2811504"/>
            <a:ext cx="476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00F05665-3179-46C4-82B6-46DBA928E726}"/>
              </a:ext>
            </a:extLst>
          </p:cNvPr>
          <p:cNvSpPr txBox="1"/>
          <p:nvPr/>
        </p:nvSpPr>
        <p:spPr>
          <a:xfrm>
            <a:off x="2362126" y="2941965"/>
            <a:ext cx="2214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1632696" y="3715303"/>
            <a:ext cx="6254003" cy="8975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. S3 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luster distribution within the six </a:t>
            </a:r>
            <a:r>
              <a:rPr lang="en-US" altLang="zh-CN" sz="1200" i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uccinia </a:t>
            </a:r>
            <a:r>
              <a:rPr lang="en-US" altLang="zh-CN" sz="1200" i="1" kern="100" dirty="0" err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triiformis</a:t>
            </a:r>
            <a:r>
              <a:rPr lang="en-US" altLang="zh-CN" sz="1200" i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. sp. </a:t>
            </a:r>
            <a:r>
              <a:rPr lang="en-US" altLang="zh-CN" sz="1200" i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ritici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populations. 21GS, 2021 Gansu; 21NX, 2021 Ningxia; 21QH, 2021 Qinghai; 22GS, 2022 Gansu; 22NX, 2022 Ningxia; 22QH, 2022 Qinghai. </a:t>
            </a:r>
            <a:endParaRPr lang="zh-CN" altLang="zh-CN" sz="1200" kern="1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" name="图片 2" descr="图表, 条形图&#10;&#10;描述已自动生成">
            <a:extLst>
              <a:ext uri="{FF2B5EF4-FFF2-40B4-BE49-F238E27FC236}">
                <a16:creationId xmlns:a16="http://schemas.microsoft.com/office/drawing/2014/main" id="{217DB8EC-5395-483C-AD63-20367B1291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9826" y="1676469"/>
            <a:ext cx="4930567" cy="2065199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A1BCDDC-6DA7-4AFB-BA27-123E4CE4B0F4}"/>
              </a:ext>
            </a:extLst>
          </p:cNvPr>
          <p:cNvSpPr txBox="1"/>
          <p:nvPr/>
        </p:nvSpPr>
        <p:spPr>
          <a:xfrm>
            <a:off x="2004201" y="1734584"/>
            <a:ext cx="5802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1G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B6AE5C8-55FF-4253-B308-1267AF75B38A}"/>
              </a:ext>
            </a:extLst>
          </p:cNvPr>
          <p:cNvSpPr txBox="1"/>
          <p:nvPr/>
        </p:nvSpPr>
        <p:spPr>
          <a:xfrm>
            <a:off x="1999826" y="2002183"/>
            <a:ext cx="5802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1NX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EE955377-6DF8-47FA-839A-E36509247443}"/>
              </a:ext>
            </a:extLst>
          </p:cNvPr>
          <p:cNvSpPr txBox="1"/>
          <p:nvPr/>
        </p:nvSpPr>
        <p:spPr>
          <a:xfrm>
            <a:off x="2004201" y="2276132"/>
            <a:ext cx="5802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1Q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7CC534A-008B-448F-8BFC-793741A5BE67}"/>
              </a:ext>
            </a:extLst>
          </p:cNvPr>
          <p:cNvSpPr txBox="1"/>
          <p:nvPr/>
        </p:nvSpPr>
        <p:spPr>
          <a:xfrm>
            <a:off x="2004201" y="2565109"/>
            <a:ext cx="5802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2G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5050A4E-2020-4931-8EF8-BFBE782D9969}"/>
              </a:ext>
            </a:extLst>
          </p:cNvPr>
          <p:cNvSpPr txBox="1"/>
          <p:nvPr/>
        </p:nvSpPr>
        <p:spPr>
          <a:xfrm>
            <a:off x="2004201" y="2832708"/>
            <a:ext cx="5802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2NX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58610F4-5863-4A5C-9502-31B221393286}"/>
              </a:ext>
            </a:extLst>
          </p:cNvPr>
          <p:cNvSpPr txBox="1"/>
          <p:nvPr/>
        </p:nvSpPr>
        <p:spPr>
          <a:xfrm>
            <a:off x="2004201" y="3102209"/>
            <a:ext cx="5802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2Q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58BCB99-9B8A-4F94-BB5C-317C0D9B6B29}"/>
              </a:ext>
            </a:extLst>
          </p:cNvPr>
          <p:cNvSpPr txBox="1"/>
          <p:nvPr/>
        </p:nvSpPr>
        <p:spPr>
          <a:xfrm>
            <a:off x="2398694" y="3393566"/>
            <a:ext cx="2349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8A2E4E7-5D72-4E20-AC69-2C986FB87AF8}"/>
              </a:ext>
            </a:extLst>
          </p:cNvPr>
          <p:cNvSpPr txBox="1"/>
          <p:nvPr/>
        </p:nvSpPr>
        <p:spPr>
          <a:xfrm>
            <a:off x="3343257" y="3402407"/>
            <a:ext cx="3238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8595078D-F6E8-466F-8299-0CB61842BA88}"/>
              </a:ext>
            </a:extLst>
          </p:cNvPr>
          <p:cNvSpPr txBox="1"/>
          <p:nvPr/>
        </p:nvSpPr>
        <p:spPr>
          <a:xfrm>
            <a:off x="4337032" y="3395947"/>
            <a:ext cx="3238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7CA995D-D026-4A14-8685-71AF741F3099}"/>
              </a:ext>
            </a:extLst>
          </p:cNvPr>
          <p:cNvSpPr txBox="1"/>
          <p:nvPr/>
        </p:nvSpPr>
        <p:spPr>
          <a:xfrm>
            <a:off x="5332396" y="3396852"/>
            <a:ext cx="3238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B1752A3-670F-4262-9FE4-1180AB609859}"/>
              </a:ext>
            </a:extLst>
          </p:cNvPr>
          <p:cNvSpPr txBox="1"/>
          <p:nvPr/>
        </p:nvSpPr>
        <p:spPr>
          <a:xfrm>
            <a:off x="6297596" y="3387215"/>
            <a:ext cx="719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(%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C43EF533-4DF8-4A54-97F1-4EC479ABFF0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53575" y="2818419"/>
            <a:ext cx="171907" cy="515722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E3CE6EAD-E59E-4EAD-A28D-AF392DA1C34A}"/>
              </a:ext>
            </a:extLst>
          </p:cNvPr>
          <p:cNvSpPr txBox="1"/>
          <p:nvPr/>
        </p:nvSpPr>
        <p:spPr>
          <a:xfrm>
            <a:off x="7083432" y="2801804"/>
            <a:ext cx="710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roup 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DAF41779-F15C-40AC-A29E-996B94094E63}"/>
              </a:ext>
            </a:extLst>
          </p:cNvPr>
          <p:cNvSpPr txBox="1"/>
          <p:nvPr/>
        </p:nvSpPr>
        <p:spPr>
          <a:xfrm>
            <a:off x="7083432" y="2968558"/>
            <a:ext cx="710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roup 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6B832BA6-1C54-4E67-83E0-BB3EBE1FA611}"/>
              </a:ext>
            </a:extLst>
          </p:cNvPr>
          <p:cNvSpPr txBox="1"/>
          <p:nvPr/>
        </p:nvSpPr>
        <p:spPr>
          <a:xfrm>
            <a:off x="7083432" y="3142956"/>
            <a:ext cx="710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roup 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F03474F1-B209-4141-881E-6A7CC06EB0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8012" y="386412"/>
            <a:ext cx="4412362" cy="3734124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A9EEF1E7-0492-4EBC-9BEF-73672ABCEED1}"/>
              </a:ext>
            </a:extLst>
          </p:cNvPr>
          <p:cNvSpPr txBox="1"/>
          <p:nvPr/>
        </p:nvSpPr>
        <p:spPr>
          <a:xfrm>
            <a:off x="1847804" y="4270004"/>
            <a:ext cx="58107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. S4 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etection of gene flow among populations based on </a:t>
            </a:r>
            <a:r>
              <a:rPr lang="en-US" altLang="zh-CN" sz="1200" i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statistics.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FF61A3E2-A217-47DA-A9C1-8623B1C94B99}"/>
              </a:ext>
            </a:extLst>
          </p:cNvPr>
          <p:cNvSpPr txBox="1"/>
          <p:nvPr/>
        </p:nvSpPr>
        <p:spPr>
          <a:xfrm>
            <a:off x="2336005" y="1807370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1G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EB2C46C-F362-4C2D-B528-26A877473F9C}"/>
              </a:ext>
            </a:extLst>
          </p:cNvPr>
          <p:cNvSpPr txBox="1"/>
          <p:nvPr/>
        </p:nvSpPr>
        <p:spPr>
          <a:xfrm>
            <a:off x="2336004" y="2068980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1Q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AD4D63E-88D7-4312-9F2B-7AF78FB75A37}"/>
              </a:ext>
            </a:extLst>
          </p:cNvPr>
          <p:cNvSpPr txBox="1"/>
          <p:nvPr/>
        </p:nvSpPr>
        <p:spPr>
          <a:xfrm>
            <a:off x="2336001" y="2330590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2G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555D1DC-5F47-46BE-9F3C-6A121D527F57}"/>
              </a:ext>
            </a:extLst>
          </p:cNvPr>
          <p:cNvSpPr txBox="1"/>
          <p:nvPr/>
        </p:nvSpPr>
        <p:spPr>
          <a:xfrm>
            <a:off x="2336000" y="2921914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1NX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E67ACD77-B2A5-4312-9DBF-641345DE9075}"/>
              </a:ext>
            </a:extLst>
          </p:cNvPr>
          <p:cNvSpPr txBox="1"/>
          <p:nvPr/>
        </p:nvSpPr>
        <p:spPr>
          <a:xfrm>
            <a:off x="2336000" y="3445134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2Q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A2090DA-B7F7-4791-9972-BA234434D367}"/>
              </a:ext>
            </a:extLst>
          </p:cNvPr>
          <p:cNvSpPr txBox="1"/>
          <p:nvPr/>
        </p:nvSpPr>
        <p:spPr>
          <a:xfrm>
            <a:off x="2967031" y="3722133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2NX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A95DEE1-F791-4ED3-85E3-5964A064D962}"/>
              </a:ext>
            </a:extLst>
          </p:cNvPr>
          <p:cNvSpPr txBox="1"/>
          <p:nvPr/>
        </p:nvSpPr>
        <p:spPr>
          <a:xfrm rot="16200000">
            <a:off x="3302785" y="516732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1G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2A3E77DE-C7DD-4CDC-9589-ED3372BF9C87}"/>
              </a:ext>
            </a:extLst>
          </p:cNvPr>
          <p:cNvSpPr txBox="1"/>
          <p:nvPr/>
        </p:nvSpPr>
        <p:spPr>
          <a:xfrm rot="16200000">
            <a:off x="3671248" y="509587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1Q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0BAE0CC-5A50-4259-BCE4-DBB57EBDD02A}"/>
              </a:ext>
            </a:extLst>
          </p:cNvPr>
          <p:cNvSpPr txBox="1"/>
          <p:nvPr/>
        </p:nvSpPr>
        <p:spPr>
          <a:xfrm rot="16200000">
            <a:off x="4088685" y="509586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2G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2F51E57-DCA8-4755-AB89-0146D3FBF1C8}"/>
              </a:ext>
            </a:extLst>
          </p:cNvPr>
          <p:cNvSpPr txBox="1"/>
          <p:nvPr/>
        </p:nvSpPr>
        <p:spPr>
          <a:xfrm rot="16200000">
            <a:off x="4497651" y="509585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1NX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6EDE6D0-C9DC-46DC-B7BF-C75A785DDE53}"/>
              </a:ext>
            </a:extLst>
          </p:cNvPr>
          <p:cNvSpPr txBox="1"/>
          <p:nvPr/>
        </p:nvSpPr>
        <p:spPr>
          <a:xfrm rot="16200000">
            <a:off x="4878497" y="516732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2Q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2AC5C25-A3FF-4C27-959F-AE7666E28888}"/>
              </a:ext>
            </a:extLst>
          </p:cNvPr>
          <p:cNvSpPr txBox="1"/>
          <p:nvPr/>
        </p:nvSpPr>
        <p:spPr>
          <a:xfrm rot="16200000">
            <a:off x="5266487" y="775569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2NX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14A89C4-91E5-494A-944A-C1452DC7D8C6}"/>
              </a:ext>
            </a:extLst>
          </p:cNvPr>
          <p:cNvSpPr txBox="1"/>
          <p:nvPr/>
        </p:nvSpPr>
        <p:spPr>
          <a:xfrm>
            <a:off x="6045991" y="1172825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AF4DF93-5941-4BF1-94E1-9392297A2E10}"/>
              </a:ext>
            </a:extLst>
          </p:cNvPr>
          <p:cNvSpPr txBox="1"/>
          <p:nvPr/>
        </p:nvSpPr>
        <p:spPr>
          <a:xfrm>
            <a:off x="6049458" y="1544235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A7FF8A3E-3407-4BD0-BA63-D9392386F441}"/>
              </a:ext>
            </a:extLst>
          </p:cNvPr>
          <p:cNvSpPr txBox="1"/>
          <p:nvPr/>
        </p:nvSpPr>
        <p:spPr>
          <a:xfrm>
            <a:off x="6046417" y="1932147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47B529A3-85B1-4C92-AE0B-6B1BD8115531}"/>
              </a:ext>
            </a:extLst>
          </p:cNvPr>
          <p:cNvSpPr txBox="1"/>
          <p:nvPr/>
        </p:nvSpPr>
        <p:spPr>
          <a:xfrm>
            <a:off x="6045991" y="2320059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3CDD1DE-A086-4D04-8C59-63AA244C7CE1}"/>
              </a:ext>
            </a:extLst>
          </p:cNvPr>
          <p:cNvSpPr txBox="1"/>
          <p:nvPr/>
        </p:nvSpPr>
        <p:spPr>
          <a:xfrm>
            <a:off x="6045991" y="2707628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E1A20AAF-FAA5-49B7-AF88-02DF14122CEF}"/>
              </a:ext>
            </a:extLst>
          </p:cNvPr>
          <p:cNvSpPr txBox="1"/>
          <p:nvPr/>
        </p:nvSpPr>
        <p:spPr>
          <a:xfrm>
            <a:off x="6045991" y="3079037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DED1ABA-64A6-4D25-8B0F-B38463C197F1}"/>
              </a:ext>
            </a:extLst>
          </p:cNvPr>
          <p:cNvSpPr txBox="1"/>
          <p:nvPr/>
        </p:nvSpPr>
        <p:spPr>
          <a:xfrm>
            <a:off x="6045991" y="3457591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3CD25F3-32C5-4AF8-8182-E689A355495C}"/>
              </a:ext>
            </a:extLst>
          </p:cNvPr>
          <p:cNvSpPr txBox="1"/>
          <p:nvPr/>
        </p:nvSpPr>
        <p:spPr>
          <a:xfrm>
            <a:off x="6043509" y="3840075"/>
            <a:ext cx="7572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19328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41</TotalTime>
  <Words>317</Words>
  <Application>Microsoft Office PowerPoint</Application>
  <PresentationFormat>自定义</PresentationFormat>
  <Paragraphs>102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ingDong Zeng</dc:creator>
  <cp:lastModifiedBy>Yan HH</cp:lastModifiedBy>
  <cp:revision>34</cp:revision>
  <dcterms:created xsi:type="dcterms:W3CDTF">2024-01-19T03:55:00Z</dcterms:created>
  <dcterms:modified xsi:type="dcterms:W3CDTF">2026-01-05T08:47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C5C9183F9DC449284CA062E90BF950C_13</vt:lpwstr>
  </property>
  <property fmtid="{D5CDD505-2E9C-101B-9397-08002B2CF9AE}" pid="3" name="KSOProductBuildVer">
    <vt:lpwstr>2052-12.1.0.17827</vt:lpwstr>
  </property>
</Properties>
</file>